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8DEF9"/>
    <a:srgbClr val="BDD7EE"/>
    <a:srgbClr val="A0A0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 autoAdjust="0"/>
    <p:restoredTop sz="95009" autoAdjust="0"/>
  </p:normalViewPr>
  <p:slideViewPr>
    <p:cSldViewPr snapToGrid="0">
      <p:cViewPr varScale="1">
        <p:scale>
          <a:sx n="109" d="100"/>
          <a:sy n="109" d="100"/>
        </p:scale>
        <p:origin x="11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E:\Laboratorio%20Giacomini\progetto%20dPCR%20breast%20(AIRC2016)\paper\1)%20liquid%20biopsy\Calcoli%20e%20grafici%20per%20pape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E:\Laboratorio%20Giacomini\progetto%20dPCR%20breast%20(AIRC2016)\paper\1)%20liquid%20biopsy\Calcoli%20e%20grafici%20per%20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C8DEF9"/>
            </a:solidFill>
            <a:ln w="3175"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per figura tessuto'!$C$102:$C$139</c:f>
              <c:strCache>
                <c:ptCount val="38"/>
                <c:pt idx="0">
                  <c:v>BRAF</c:v>
                </c:pt>
                <c:pt idx="1">
                  <c:v>CDKN2A</c:v>
                </c:pt>
                <c:pt idx="2">
                  <c:v>EZH2</c:v>
                </c:pt>
                <c:pt idx="3">
                  <c:v>FGFR2</c:v>
                </c:pt>
                <c:pt idx="4">
                  <c:v>GNAS</c:v>
                </c:pt>
                <c:pt idx="5">
                  <c:v>IDH1</c:v>
                </c:pt>
                <c:pt idx="6">
                  <c:v>KDR</c:v>
                </c:pt>
                <c:pt idx="7">
                  <c:v>MLH1</c:v>
                </c:pt>
                <c:pt idx="8">
                  <c:v>NOTCH</c:v>
                </c:pt>
                <c:pt idx="9">
                  <c:v>AKT1</c:v>
                </c:pt>
                <c:pt idx="10">
                  <c:v>ERBB2</c:v>
                </c:pt>
                <c:pt idx="11">
                  <c:v>GNAQ</c:v>
                </c:pt>
                <c:pt idx="12">
                  <c:v>HRAS</c:v>
                </c:pt>
                <c:pt idx="13">
                  <c:v>IDH2</c:v>
                </c:pt>
                <c:pt idx="14">
                  <c:v>MET</c:v>
                </c:pt>
                <c:pt idx="15">
                  <c:v>SMARCB1</c:v>
                </c:pt>
                <c:pt idx="16">
                  <c:v>APC</c:v>
                </c:pt>
                <c:pt idx="17">
                  <c:v>CTNNB1</c:v>
                </c:pt>
                <c:pt idx="18">
                  <c:v>EGFR</c:v>
                </c:pt>
                <c:pt idx="19">
                  <c:v>FGFR3</c:v>
                </c:pt>
                <c:pt idx="20">
                  <c:v>HNF1A</c:v>
                </c:pt>
                <c:pt idx="21">
                  <c:v>JAK3</c:v>
                </c:pt>
                <c:pt idx="22">
                  <c:v>NRAS</c:v>
                </c:pt>
                <c:pt idx="23">
                  <c:v>PDGFRA</c:v>
                </c:pt>
                <c:pt idx="24">
                  <c:v>SMO</c:v>
                </c:pt>
                <c:pt idx="25">
                  <c:v>VHL</c:v>
                </c:pt>
                <c:pt idx="26">
                  <c:v>ABL1</c:v>
                </c:pt>
                <c:pt idx="27">
                  <c:v>ATM</c:v>
                </c:pt>
                <c:pt idx="28">
                  <c:v>FBWX7</c:v>
                </c:pt>
                <c:pt idx="29">
                  <c:v>KIT</c:v>
                </c:pt>
                <c:pt idx="30">
                  <c:v>KRAS</c:v>
                </c:pt>
                <c:pt idx="31">
                  <c:v>PTPN11</c:v>
                </c:pt>
                <c:pt idx="32">
                  <c:v>CDH1</c:v>
                </c:pt>
                <c:pt idx="33">
                  <c:v>ERBB4</c:v>
                </c:pt>
                <c:pt idx="34">
                  <c:v>PIK3CA</c:v>
                </c:pt>
                <c:pt idx="35">
                  <c:v>PTEN</c:v>
                </c:pt>
                <c:pt idx="36">
                  <c:v>SMAD4</c:v>
                </c:pt>
                <c:pt idx="37">
                  <c:v>TP53</c:v>
                </c:pt>
              </c:strCache>
            </c:strRef>
          </c:cat>
          <c:val>
            <c:numRef>
              <c:f>'per figura tessuto'!$D$102:$D$139</c:f>
              <c:numCache>
                <c:formatCode>General</c:formatCode>
                <c:ptCount val="3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2</c:v>
                </c:pt>
                <c:pt idx="10">
                  <c:v>2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3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  <c:pt idx="20">
                  <c:v>3</c:v>
                </c:pt>
                <c:pt idx="21">
                  <c:v>3</c:v>
                </c:pt>
                <c:pt idx="22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3</c:v>
                </c:pt>
                <c:pt idx="26">
                  <c:v>4</c:v>
                </c:pt>
                <c:pt idx="27">
                  <c:v>4</c:v>
                </c:pt>
                <c:pt idx="28">
                  <c:v>4</c:v>
                </c:pt>
                <c:pt idx="29">
                  <c:v>4</c:v>
                </c:pt>
                <c:pt idx="30">
                  <c:v>4</c:v>
                </c:pt>
                <c:pt idx="31">
                  <c:v>4</c:v>
                </c:pt>
                <c:pt idx="32">
                  <c:v>5</c:v>
                </c:pt>
                <c:pt idx="33">
                  <c:v>5</c:v>
                </c:pt>
                <c:pt idx="34">
                  <c:v>5</c:v>
                </c:pt>
                <c:pt idx="35">
                  <c:v>7</c:v>
                </c:pt>
                <c:pt idx="36">
                  <c:v>12</c:v>
                </c:pt>
                <c:pt idx="37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D3-4688-803E-FC4FC0B8F9A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"/>
        <c:axId val="-1127339568"/>
        <c:axId val="-1127337792"/>
      </c:barChart>
      <c:catAx>
        <c:axId val="-112733956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127337792"/>
        <c:crosses val="autoZero"/>
        <c:auto val="1"/>
        <c:lblAlgn val="ctr"/>
        <c:lblOffset val="100"/>
        <c:noMultiLvlLbl val="0"/>
      </c:catAx>
      <c:valAx>
        <c:axId val="-1127337792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-112733956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it-IT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C8DEF9"/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'blood mutations t0 e relapse'!$Q$7:$Q$10</c:f>
              <c:strCache>
                <c:ptCount val="4"/>
                <c:pt idx="0">
                  <c:v>TP53</c:v>
                </c:pt>
                <c:pt idx="1">
                  <c:v>ERBB2</c:v>
                </c:pt>
                <c:pt idx="2">
                  <c:v>PIK3CA</c:v>
                </c:pt>
                <c:pt idx="3">
                  <c:v>ESR1</c:v>
                </c:pt>
              </c:strCache>
            </c:strRef>
          </c:cat>
          <c:val>
            <c:numRef>
              <c:f>'blood mutations t0 e relapse'!$R$7:$R$10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5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D3-4688-803E-FC4FC0B8F9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axId val="-1127146496"/>
        <c:axId val="-1127143984"/>
      </c:barChart>
      <c:catAx>
        <c:axId val="-112714649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127143984"/>
        <c:crosses val="autoZero"/>
        <c:auto val="1"/>
        <c:lblAlgn val="ctr"/>
        <c:lblOffset val="100"/>
        <c:noMultiLvlLbl val="0"/>
      </c:catAx>
      <c:valAx>
        <c:axId val="-1127143984"/>
        <c:scaling>
          <c:orientation val="minMax"/>
          <c:max val="8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-1127146496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it-IT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8BB19B-0CB3-9E42-ACB1-96657B46D74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8ABA3A-2C74-7D44-BCE6-CA131166DFB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3444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8ABA3A-2C74-7D44-BCE6-CA131166DFB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711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F231F5-5C32-410A-9E74-A5C8F4D24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61513E0-4318-4994-9864-449DE3044B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C04BEC-F3EC-4AE7-B24A-A20A09FF8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86E674B-FAF2-4CA6-A009-1F28D0B7C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E92C24F-323F-4140-8732-9BD501023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2570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43E52D2-B562-4DAC-8284-22C584BD08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C6DD4D8-B540-4972-8454-E5C02DCD17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36E068-DE90-4399-A894-569254C79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1C4836F-53CA-40B1-9B3E-F288AAAD2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32033D-B848-4250-871B-098A2A955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993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76D55AC-B7BD-4F0D-999C-F148DE7AA2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DED5029-C280-43D8-AD07-F358160C6E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763066B-A22E-4464-A637-15F9B5A98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F00249-A470-42B8-AF6E-F4A9C2F0C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DCEA51-92DC-492A-96F5-8F7DE19E8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280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83345B-914C-4C32-BE26-47283A418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987109-4439-4DEE-AAA2-360512EA84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DEB95F-9685-442E-90CE-8BA17043B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FC3501B-9988-4A46-93C8-EE75D9C0A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DE1A09-3CEC-4E90-AAA6-20046F45B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849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741BE3D-2ACD-4118-A8EC-532A7A60A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9DD6ED3-DA0C-4FD3-B0D8-6B21641F62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6F71AE-A4A2-4CD4-9A73-C53941461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8781E6-114E-4C55-A108-B13E491A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83E18C-6BF8-40E5-A3C0-A1A53A9E3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2082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EE9E1EC-E7E1-4E5D-8239-9C2910BB8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E5BB79E-DF5B-4547-9E8F-9918409E52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DC9F39B-3539-408C-971D-8F8B4D3783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687F04C-7E3F-46A3-B39D-6B1EF8DEE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038D2C6-2163-42E3-A693-22AAAF5EC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489225E-9C62-4B33-84C0-5AA3F66DE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1231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F06A95-106F-4910-A747-1EA28303C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1121A81-83E3-427A-BD25-1F1EB0CB6A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A5F7F1C-0CD1-43FF-B872-83BA518A65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C7FA546-BC80-444F-A79E-AEC8230554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C3331FB-6718-4114-BC31-0D2517096B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FA6F996-7FD4-485E-A30F-40CC34F67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AAFB482-24B1-4011-BFE2-85B684A22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F9626B1-B291-4BF1-BCB4-0DDFA6709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9122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B70730C-3FE8-4550-9ACD-0FFF1061F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3AACA91-2E77-4595-B9A7-AAF7F133F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BC1E9B0-275E-4091-96C8-FB4366250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318267C-98DF-4DFE-8BCB-D242CD520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7780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3F4FDC3-2AD5-41F1-9AD1-AD49B6423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74908A3-EF0D-41DD-B6BE-AB4475700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B348FDF-E747-4662-91C6-82794A991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9248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19ACCB-9262-414A-8A7C-14C095DAF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2A16037-46A0-464B-A154-080F0A5CF7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F59BBF5-C08E-47AF-8D7D-2325906E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B9D1731-8127-4CFB-B108-D333F43FA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D41CC74-2EC5-4D32-B05C-AD3CEC41E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028E75C-A006-461F-8BFA-42C2897C2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4567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D30DBF-44F2-4194-8529-D61D50AD7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DBFEB32-4E9F-4BBF-970F-0ED96D2396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31603A-6A30-4E22-BE84-A6C40BCAF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BC30447-931F-4455-A91C-9BCEE49F3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2017471-3E65-47FA-A341-2DD759257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5360CBA-7BAD-411A-BCD1-3941BB86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6113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9806D2E-2212-49F7-9205-FBE05C7B0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D0E2BC0-8E4D-4D80-9132-8CFD1748E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C0748C-92C6-408E-A826-94B887C8B7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DE34D-4120-497C-BF34-DBDC02D45DE3}" type="datetimeFigureOut">
              <a:rPr lang="it-IT" smtClean="0"/>
              <a:t>04/0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5B0EF3-F288-4880-A3DE-4013C5F043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8B8FC7D-C85B-4A6F-B3EB-A4551C46DD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4649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microsoft.com/office/2007/relationships/hdphoto" Target="../media/hdphoto1.wdp"/><Relationship Id="rId12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chart" Target="../charts/chart2.xml"/><Relationship Id="rId5" Type="http://schemas.openxmlformats.org/officeDocument/2006/relationships/chart" Target="../charts/chart1.xml"/><Relationship Id="rId15" Type="http://schemas.openxmlformats.org/officeDocument/2006/relationships/image" Target="../media/image7.emf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DBA9877E-AB32-4FA4-B7A4-77EF3443BF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0086" y="1054143"/>
            <a:ext cx="1550218" cy="1062000"/>
          </a:xfrm>
          <a:prstGeom prst="rect">
            <a:avLst/>
          </a:prstGeom>
        </p:spPr>
      </p:pic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63449FE2-78FA-4DB6-B1CB-DE3903B6421B}"/>
              </a:ext>
            </a:extLst>
          </p:cNvPr>
          <p:cNvSpPr txBox="1"/>
          <p:nvPr/>
        </p:nvSpPr>
        <p:spPr>
          <a:xfrm>
            <a:off x="4666543" y="2198350"/>
            <a:ext cx="29910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SNVs</a:t>
            </a:r>
            <a:endParaRPr lang="it-IT" sz="400" dirty="0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5EB7E409-0151-4D3A-A3EA-7CA971792D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100" y="1056524"/>
            <a:ext cx="1632228" cy="4975200"/>
          </a:xfrm>
          <a:prstGeom prst="rect">
            <a:avLst/>
          </a:prstGeom>
        </p:spPr>
      </p:pic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D579F8B0-9AF3-47A7-960E-36C55F02A347}"/>
              </a:ext>
            </a:extLst>
          </p:cNvPr>
          <p:cNvSpPr txBox="1"/>
          <p:nvPr/>
        </p:nvSpPr>
        <p:spPr>
          <a:xfrm>
            <a:off x="520750" y="364300"/>
            <a:ext cx="258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a</a:t>
            </a:r>
          </a:p>
        </p:txBody>
      </p:sp>
      <p:graphicFrame>
        <p:nvGraphicFramePr>
          <p:cNvPr id="39" name="Grafico 38">
            <a:extLst>
              <a:ext uri="{FF2B5EF4-FFF2-40B4-BE49-F238E27FC236}">
                <a16:creationId xmlns:a16="http://schemas.microsoft.com/office/drawing/2014/main" id="{00000000-0008-0000-06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969338"/>
              </p:ext>
            </p:extLst>
          </p:nvPr>
        </p:nvGraphicFramePr>
        <p:xfrm>
          <a:off x="2130770" y="1506093"/>
          <a:ext cx="770400" cy="473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0C53B691-17D7-408C-93D4-ED4E3276F84C}"/>
              </a:ext>
            </a:extLst>
          </p:cNvPr>
          <p:cNvSpPr txBox="1"/>
          <p:nvPr/>
        </p:nvSpPr>
        <p:spPr>
          <a:xfrm rot="16200000">
            <a:off x="544900" y="772373"/>
            <a:ext cx="609576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dirty="0"/>
              <a:t># </a:t>
            </a:r>
            <a:r>
              <a:rPr lang="it-IT" sz="400" dirty="0" err="1"/>
              <a:t>somatic</a:t>
            </a:r>
            <a:r>
              <a:rPr lang="it-IT" sz="400" dirty="0"/>
              <a:t> </a:t>
            </a:r>
            <a:r>
              <a:rPr lang="it-IT" sz="400" dirty="0" err="1"/>
              <a:t>mutations</a:t>
            </a:r>
            <a:endParaRPr lang="it-IT" sz="400" dirty="0"/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E6D9D268-704F-46F5-A2CB-28599EBE3B7A}"/>
              </a:ext>
            </a:extLst>
          </p:cNvPr>
          <p:cNvSpPr txBox="1"/>
          <p:nvPr/>
        </p:nvSpPr>
        <p:spPr>
          <a:xfrm>
            <a:off x="2245215" y="6128081"/>
            <a:ext cx="45435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SNVs</a:t>
            </a:r>
            <a:endParaRPr lang="it-IT" sz="400" dirty="0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04518DA9-87D0-4DBB-A527-C613858DCF21}"/>
              </a:ext>
            </a:extLst>
          </p:cNvPr>
          <p:cNvSpPr txBox="1"/>
          <p:nvPr/>
        </p:nvSpPr>
        <p:spPr>
          <a:xfrm rot="16200000">
            <a:off x="3037864" y="764843"/>
            <a:ext cx="64080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dirty="0"/>
              <a:t># </a:t>
            </a:r>
            <a:r>
              <a:rPr lang="it-IT" sz="400" dirty="0" err="1"/>
              <a:t>somatic</a:t>
            </a:r>
            <a:r>
              <a:rPr lang="it-IT" sz="400" dirty="0"/>
              <a:t> </a:t>
            </a:r>
            <a:r>
              <a:rPr lang="it-IT" sz="400" dirty="0" err="1"/>
              <a:t>mutations</a:t>
            </a:r>
            <a:endParaRPr lang="it-IT" sz="400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3D67AB7B-AD2A-4544-975A-580339C412B3}"/>
              </a:ext>
            </a:extLst>
          </p:cNvPr>
          <p:cNvSpPr txBox="1"/>
          <p:nvPr/>
        </p:nvSpPr>
        <p:spPr>
          <a:xfrm>
            <a:off x="2989271" y="36430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A325CF6-E970-418D-BCBB-F4400385C1D1}"/>
              </a:ext>
            </a:extLst>
          </p:cNvPr>
          <p:cNvSpPr txBox="1"/>
          <p:nvPr/>
        </p:nvSpPr>
        <p:spPr>
          <a:xfrm>
            <a:off x="2989271" y="2980266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c</a:t>
            </a:r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1B11E4F3-D620-4DCA-A3AD-520145449803}"/>
              </a:ext>
            </a:extLst>
          </p:cNvPr>
          <p:cNvSpPr/>
          <p:nvPr/>
        </p:nvSpPr>
        <p:spPr>
          <a:xfrm>
            <a:off x="3384094" y="3380114"/>
            <a:ext cx="720000" cy="720969"/>
          </a:xfrm>
          <a:prstGeom prst="ellipse">
            <a:avLst/>
          </a:prstGeom>
          <a:solidFill>
            <a:srgbClr val="C8DEF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Ovale 17">
            <a:extLst>
              <a:ext uri="{FF2B5EF4-FFF2-40B4-BE49-F238E27FC236}">
                <a16:creationId xmlns:a16="http://schemas.microsoft.com/office/drawing/2014/main" id="{25D5C74A-8028-4FB8-907E-3178B40AB561}"/>
              </a:ext>
            </a:extLst>
          </p:cNvPr>
          <p:cNvSpPr/>
          <p:nvPr/>
        </p:nvSpPr>
        <p:spPr>
          <a:xfrm>
            <a:off x="3920891" y="3503568"/>
            <a:ext cx="360000" cy="468000"/>
          </a:xfrm>
          <a:prstGeom prst="ellipse">
            <a:avLst/>
          </a:prstGeom>
          <a:solidFill>
            <a:schemeClr val="accent2">
              <a:lumMod val="75000"/>
              <a:alpha val="46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2707C955-A2E8-47DC-A76C-040D4602E9C9}"/>
              </a:ext>
            </a:extLst>
          </p:cNvPr>
          <p:cNvSpPr txBox="1"/>
          <p:nvPr/>
        </p:nvSpPr>
        <p:spPr>
          <a:xfrm>
            <a:off x="3573193" y="3632876"/>
            <a:ext cx="3385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/>
              <a:t>136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5A92F6D6-BE3A-4BED-BDE3-C940766D245F}"/>
              </a:ext>
            </a:extLst>
          </p:cNvPr>
          <p:cNvSpPr txBox="1"/>
          <p:nvPr/>
        </p:nvSpPr>
        <p:spPr>
          <a:xfrm>
            <a:off x="4064894" y="363287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/>
              <a:t>7</a:t>
            </a:r>
          </a:p>
        </p:txBody>
      </p:sp>
      <p:pic>
        <p:nvPicPr>
          <p:cNvPr id="22" name="Immagine 21">
            <a:extLst>
              <a:ext uri="{FF2B5EF4-FFF2-40B4-BE49-F238E27FC236}">
                <a16:creationId xmlns:a16="http://schemas.microsoft.com/office/drawing/2014/main" id="{D68637AE-48F4-40A0-84AB-C6DC52E343D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40241" y="3313267"/>
            <a:ext cx="195540" cy="135617"/>
          </a:xfrm>
          <a:prstGeom prst="rect">
            <a:avLst/>
          </a:prstGeom>
        </p:spPr>
      </p:pic>
      <p:grpSp>
        <p:nvGrpSpPr>
          <p:cNvPr id="23" name="Gruppo 22">
            <a:extLst>
              <a:ext uri="{FF2B5EF4-FFF2-40B4-BE49-F238E27FC236}">
                <a16:creationId xmlns:a16="http://schemas.microsoft.com/office/drawing/2014/main" id="{68634D12-86A2-478A-818D-6CF84B6CC36C}"/>
              </a:ext>
            </a:extLst>
          </p:cNvPr>
          <p:cNvGrpSpPr/>
          <p:nvPr/>
        </p:nvGrpSpPr>
        <p:grpSpPr>
          <a:xfrm>
            <a:off x="4062461" y="3252252"/>
            <a:ext cx="91436" cy="230659"/>
            <a:chOff x="7637707" y="1647289"/>
            <a:chExt cx="120653" cy="322878"/>
          </a:xfrm>
        </p:grpSpPr>
        <p:pic>
          <p:nvPicPr>
            <p:cNvPr id="24" name="Immagine 23">
              <a:extLst>
                <a:ext uri="{FF2B5EF4-FFF2-40B4-BE49-F238E27FC236}">
                  <a16:creationId xmlns:a16="http://schemas.microsoft.com/office/drawing/2014/main" id="{CC7862EF-0AA3-4362-813E-FA473638B2B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2646" b="98413" l="8511" r="89362">
                          <a14:foregroundMark x1="23404" y1="9524" x2="23404" y2="9524"/>
                          <a14:foregroundMark x1="65957" y1="8466" x2="65957" y2="8466"/>
                          <a14:foregroundMark x1="74468" y1="8466" x2="74468" y2="8466"/>
                          <a14:foregroundMark x1="70213" y1="4233" x2="70213" y2="4233"/>
                          <a14:foregroundMark x1="63830" y1="2646" x2="63830" y2="2646"/>
                          <a14:foregroundMark x1="40426" y1="91534" x2="40426" y2="91534"/>
                          <a14:foregroundMark x1="55319" y1="93122" x2="55319" y2="93122"/>
                          <a14:foregroundMark x1="51064" y1="96296" x2="51064" y2="96296"/>
                          <a14:foregroundMark x1="82979" y1="48148" x2="82979" y2="48148"/>
                          <a14:foregroundMark x1="85106" y1="56085" x2="85106" y2="56085"/>
                          <a14:foregroundMark x1="82979" y1="62963" x2="82979" y2="62963"/>
                          <a14:foregroundMark x1="82979" y1="71429" x2="82979" y2="71429"/>
                          <a14:foregroundMark x1="80851" y1="78307" x2="80851" y2="78307"/>
                          <a14:foregroundMark x1="51064" y1="97884" x2="51064" y2="97884"/>
                          <a14:foregroundMark x1="42553" y1="98413" x2="42553" y2="98413"/>
                          <a14:foregroundMark x1="29787" y1="96825" x2="29787" y2="96825"/>
                          <a14:foregroundMark x1="23404" y1="94709" x2="23404" y2="94709"/>
                          <a14:foregroundMark x1="14894" y1="90476" x2="14894" y2="90476"/>
                          <a14:foregroundMark x1="17021" y1="86772" x2="17021" y2="86772"/>
                          <a14:foregroundMark x1="17021" y1="83069" x2="17021" y2="83069"/>
                          <a14:foregroundMark x1="17021" y1="79894" x2="17021" y2="79894"/>
                          <a14:foregroundMark x1="14894" y1="76190" x2="14894" y2="76190"/>
                          <a14:foregroundMark x1="14894" y1="72487" x2="14894" y2="72487"/>
                          <a14:foregroundMark x1="14894" y1="68783" x2="14894" y2="68783"/>
                          <a14:foregroundMark x1="14894" y1="65079" x2="14894" y2="65079"/>
                          <a14:foregroundMark x1="14894" y1="60847" x2="14894" y2="60847"/>
                          <a14:foregroundMark x1="14894" y1="56614" x2="14894" y2="56614"/>
                          <a14:foregroundMark x1="14894" y1="52910" x2="14894" y2="52910"/>
                          <a14:foregroundMark x1="14894" y1="49735" x2="14894" y2="49735"/>
                          <a14:foregroundMark x1="14894" y1="46561" x2="14894" y2="46561"/>
                          <a14:foregroundMark x1="42553" y1="15344" x2="42553" y2="15344"/>
                          <a14:foregroundMark x1="57447" y1="13757" x2="57447" y2="13757"/>
                          <a14:foregroundMark x1="63830" y1="16402" x2="63830" y2="16402"/>
                          <a14:foregroundMark x1="38298" y1="2646" x2="38298" y2="2646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081121">
              <a:off x="7688116" y="1647289"/>
              <a:ext cx="60930" cy="245012"/>
            </a:xfrm>
            <a:prstGeom prst="rect">
              <a:avLst/>
            </a:prstGeom>
          </p:spPr>
        </p:pic>
        <p:pic>
          <p:nvPicPr>
            <p:cNvPr id="25" name="Immagine 24">
              <a:extLst>
                <a:ext uri="{FF2B5EF4-FFF2-40B4-BE49-F238E27FC236}">
                  <a16:creationId xmlns:a16="http://schemas.microsoft.com/office/drawing/2014/main" id="{17FE9B7E-025F-4ABD-A685-D17BEAEF9BD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2646" b="98413" l="8511" r="89362">
                          <a14:foregroundMark x1="23404" y1="9524" x2="23404" y2="9524"/>
                          <a14:foregroundMark x1="65957" y1="8466" x2="65957" y2="8466"/>
                          <a14:foregroundMark x1="74468" y1="8466" x2="74468" y2="8466"/>
                          <a14:foregroundMark x1="70213" y1="4233" x2="70213" y2="4233"/>
                          <a14:foregroundMark x1="63830" y1="2646" x2="63830" y2="2646"/>
                          <a14:foregroundMark x1="40426" y1="91534" x2="40426" y2="91534"/>
                          <a14:foregroundMark x1="55319" y1="93122" x2="55319" y2="93122"/>
                          <a14:foregroundMark x1="51064" y1="96296" x2="51064" y2="96296"/>
                          <a14:foregroundMark x1="82979" y1="48148" x2="82979" y2="48148"/>
                          <a14:foregroundMark x1="85106" y1="56085" x2="85106" y2="56085"/>
                          <a14:foregroundMark x1="82979" y1="62963" x2="82979" y2="62963"/>
                          <a14:foregroundMark x1="82979" y1="71429" x2="82979" y2="71429"/>
                          <a14:foregroundMark x1="80851" y1="78307" x2="80851" y2="78307"/>
                          <a14:foregroundMark x1="51064" y1="97884" x2="51064" y2="97884"/>
                          <a14:foregroundMark x1="42553" y1="98413" x2="42553" y2="98413"/>
                          <a14:foregroundMark x1="29787" y1="96825" x2="29787" y2="96825"/>
                          <a14:foregroundMark x1="23404" y1="94709" x2="23404" y2="94709"/>
                          <a14:foregroundMark x1="14894" y1="90476" x2="14894" y2="90476"/>
                          <a14:foregroundMark x1="17021" y1="86772" x2="17021" y2="86772"/>
                          <a14:foregroundMark x1="17021" y1="83069" x2="17021" y2="83069"/>
                          <a14:foregroundMark x1="17021" y1="79894" x2="17021" y2="79894"/>
                          <a14:foregroundMark x1="14894" y1="76190" x2="14894" y2="76190"/>
                          <a14:foregroundMark x1="14894" y1="72487" x2="14894" y2="72487"/>
                          <a14:foregroundMark x1="14894" y1="68783" x2="14894" y2="68783"/>
                          <a14:foregroundMark x1="14894" y1="65079" x2="14894" y2="65079"/>
                          <a14:foregroundMark x1="14894" y1="60847" x2="14894" y2="60847"/>
                          <a14:foregroundMark x1="14894" y1="56614" x2="14894" y2="56614"/>
                          <a14:foregroundMark x1="14894" y1="52910" x2="14894" y2="52910"/>
                          <a14:foregroundMark x1="14894" y1="49735" x2="14894" y2="49735"/>
                          <a14:foregroundMark x1="14894" y1="46561" x2="14894" y2="46561"/>
                          <a14:foregroundMark x1="42553" y1="15344" x2="42553" y2="15344"/>
                          <a14:foregroundMark x1="57447" y1="13757" x2="57447" y2="13757"/>
                          <a14:foregroundMark x1="63830" y1="16402" x2="63830" y2="16402"/>
                          <a14:foregroundMark x1="38298" y1="2646" x2="38298" y2="2646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081121">
              <a:off x="7637707" y="1683755"/>
              <a:ext cx="60930" cy="245012"/>
            </a:xfrm>
            <a:prstGeom prst="rect">
              <a:avLst/>
            </a:prstGeom>
          </p:spPr>
        </p:pic>
        <p:pic>
          <p:nvPicPr>
            <p:cNvPr id="26" name="Immagine 25">
              <a:extLst>
                <a:ext uri="{FF2B5EF4-FFF2-40B4-BE49-F238E27FC236}">
                  <a16:creationId xmlns:a16="http://schemas.microsoft.com/office/drawing/2014/main" id="{E4B7A0E5-00E1-4C51-8108-85997D19709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2646" b="98413" l="8511" r="89362">
                          <a14:foregroundMark x1="23404" y1="9524" x2="23404" y2="9524"/>
                          <a14:foregroundMark x1="65957" y1="8466" x2="65957" y2="8466"/>
                          <a14:foregroundMark x1="74468" y1="8466" x2="74468" y2="8466"/>
                          <a14:foregroundMark x1="70213" y1="4233" x2="70213" y2="4233"/>
                          <a14:foregroundMark x1="63830" y1="2646" x2="63830" y2="2646"/>
                          <a14:foregroundMark x1="40426" y1="91534" x2="40426" y2="91534"/>
                          <a14:foregroundMark x1="55319" y1="93122" x2="55319" y2="93122"/>
                          <a14:foregroundMark x1="51064" y1="96296" x2="51064" y2="96296"/>
                          <a14:foregroundMark x1="82979" y1="48148" x2="82979" y2="48148"/>
                          <a14:foregroundMark x1="85106" y1="56085" x2="85106" y2="56085"/>
                          <a14:foregroundMark x1="82979" y1="62963" x2="82979" y2="62963"/>
                          <a14:foregroundMark x1="82979" y1="71429" x2="82979" y2="71429"/>
                          <a14:foregroundMark x1="80851" y1="78307" x2="80851" y2="78307"/>
                          <a14:foregroundMark x1="51064" y1="97884" x2="51064" y2="97884"/>
                          <a14:foregroundMark x1="42553" y1="98413" x2="42553" y2="98413"/>
                          <a14:foregroundMark x1="29787" y1="96825" x2="29787" y2="96825"/>
                          <a14:foregroundMark x1="23404" y1="94709" x2="23404" y2="94709"/>
                          <a14:foregroundMark x1="14894" y1="90476" x2="14894" y2="90476"/>
                          <a14:foregroundMark x1="17021" y1="86772" x2="17021" y2="86772"/>
                          <a14:foregroundMark x1="17021" y1="83069" x2="17021" y2="83069"/>
                          <a14:foregroundMark x1="17021" y1="79894" x2="17021" y2="79894"/>
                          <a14:foregroundMark x1="14894" y1="76190" x2="14894" y2="76190"/>
                          <a14:foregroundMark x1="14894" y1="72487" x2="14894" y2="72487"/>
                          <a14:foregroundMark x1="14894" y1="68783" x2="14894" y2="68783"/>
                          <a14:foregroundMark x1="14894" y1="65079" x2="14894" y2="65079"/>
                          <a14:foregroundMark x1="14894" y1="60847" x2="14894" y2="60847"/>
                          <a14:foregroundMark x1="14894" y1="56614" x2="14894" y2="56614"/>
                          <a14:foregroundMark x1="14894" y1="52910" x2="14894" y2="52910"/>
                          <a14:foregroundMark x1="14894" y1="49735" x2="14894" y2="49735"/>
                          <a14:foregroundMark x1="14894" y1="46561" x2="14894" y2="46561"/>
                          <a14:foregroundMark x1="42553" y1="15344" x2="42553" y2="15344"/>
                          <a14:foregroundMark x1="57447" y1="13757" x2="57447" y2="13757"/>
                          <a14:foregroundMark x1="63830" y1="16402" x2="63830" y2="16402"/>
                          <a14:foregroundMark x1="38298" y1="2646" x2="38298" y2="2646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081121">
              <a:off x="7697430" y="1725155"/>
              <a:ext cx="60930" cy="245012"/>
            </a:xfrm>
            <a:prstGeom prst="rect">
              <a:avLst/>
            </a:prstGeom>
          </p:spPr>
        </p:pic>
      </p:grp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00E324BC-344C-4E3B-A59D-1E7B6A9C0E9A}"/>
              </a:ext>
            </a:extLst>
          </p:cNvPr>
          <p:cNvSpPr txBox="1"/>
          <p:nvPr/>
        </p:nvSpPr>
        <p:spPr>
          <a:xfrm>
            <a:off x="3892443" y="363287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/>
              <a:t>7</a:t>
            </a:r>
          </a:p>
        </p:txBody>
      </p:sp>
      <p:pic>
        <p:nvPicPr>
          <p:cNvPr id="51" name="Immagine 50">
            <a:extLst>
              <a:ext uri="{FF2B5EF4-FFF2-40B4-BE49-F238E27FC236}">
                <a16:creationId xmlns:a16="http://schemas.microsoft.com/office/drawing/2014/main" id="{AFCF9320-8785-4651-81F4-D25A83105D9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31102" y="2371286"/>
            <a:ext cx="771525" cy="452438"/>
          </a:xfrm>
          <a:prstGeom prst="rect">
            <a:avLst/>
          </a:prstGeom>
        </p:spPr>
      </p:pic>
      <p:graphicFrame>
        <p:nvGraphicFramePr>
          <p:cNvPr id="29" name="Grafico 28">
            <a:extLst>
              <a:ext uri="{FF2B5EF4-FFF2-40B4-BE49-F238E27FC236}">
                <a16:creationId xmlns:a16="http://schemas.microsoft.com/office/drawing/2014/main" id="{00000000-0008-0000-07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8112165"/>
              </p:ext>
            </p:extLst>
          </p:nvPr>
        </p:nvGraphicFramePr>
        <p:xfrm>
          <a:off x="4554513" y="1506093"/>
          <a:ext cx="518400" cy="82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27133180-24BF-4482-8A56-A24FF49FAE10}"/>
              </a:ext>
            </a:extLst>
          </p:cNvPr>
          <p:cNvSpPr txBox="1"/>
          <p:nvPr/>
        </p:nvSpPr>
        <p:spPr>
          <a:xfrm>
            <a:off x="3083174" y="3185879"/>
            <a:ext cx="609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err="1"/>
              <a:t>Tissue</a:t>
            </a:r>
            <a:endParaRPr lang="it-IT" sz="700" dirty="0"/>
          </a:p>
          <a:p>
            <a:pPr algn="ctr"/>
            <a:r>
              <a:rPr lang="it-IT" sz="700" dirty="0" err="1"/>
              <a:t>only</a:t>
            </a:r>
            <a:endParaRPr lang="it-IT" sz="700" dirty="0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C20526AF-A9C8-4825-9F3E-16AB67C29CDF}"/>
              </a:ext>
            </a:extLst>
          </p:cNvPr>
          <p:cNvSpPr txBox="1"/>
          <p:nvPr/>
        </p:nvSpPr>
        <p:spPr>
          <a:xfrm>
            <a:off x="4085459" y="3379053"/>
            <a:ext cx="609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Blood</a:t>
            </a:r>
          </a:p>
          <a:p>
            <a:pPr algn="ctr"/>
            <a:r>
              <a:rPr lang="it-IT" sz="700" dirty="0" err="1"/>
              <a:t>only</a:t>
            </a:r>
            <a:endParaRPr lang="it-IT" sz="700" dirty="0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4CF42F31-55A3-4672-BEC0-A0F022B0A342}"/>
              </a:ext>
            </a:extLst>
          </p:cNvPr>
          <p:cNvSpPr txBox="1"/>
          <p:nvPr/>
        </p:nvSpPr>
        <p:spPr>
          <a:xfrm>
            <a:off x="3898666" y="4022280"/>
            <a:ext cx="6939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err="1"/>
              <a:t>shared</a:t>
            </a:r>
            <a:endParaRPr lang="it-IT" sz="700" dirty="0"/>
          </a:p>
        </p:txBody>
      </p:sp>
      <p:cxnSp>
        <p:nvCxnSpPr>
          <p:cNvPr id="4" name="Connettore 2 3">
            <a:extLst>
              <a:ext uri="{FF2B5EF4-FFF2-40B4-BE49-F238E27FC236}">
                <a16:creationId xmlns:a16="http://schemas.microsoft.com/office/drawing/2014/main" id="{4F4D33CB-BBAA-4C2E-AA14-B3E1087E1E0A}"/>
              </a:ext>
            </a:extLst>
          </p:cNvPr>
          <p:cNvCxnSpPr>
            <a:cxnSpLocks/>
          </p:cNvCxnSpPr>
          <p:nvPr/>
        </p:nvCxnSpPr>
        <p:spPr>
          <a:xfrm flipH="1" flipV="1">
            <a:off x="4013904" y="3804464"/>
            <a:ext cx="114501" cy="217816"/>
          </a:xfrm>
          <a:prstGeom prst="straightConnector1">
            <a:avLst/>
          </a:prstGeom>
          <a:ln w="63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BDA6DEBD-47E7-4516-A094-8FF6E3F5A7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1421995"/>
              </p:ext>
            </p:extLst>
          </p:nvPr>
        </p:nvGraphicFramePr>
        <p:xfrm>
          <a:off x="875504" y="521387"/>
          <a:ext cx="1403704" cy="6657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986605" imgH="1416486" progId="Prism8.Document">
                  <p:embed/>
                </p:oleObj>
              </mc:Choice>
              <mc:Fallback>
                <p:oleObj name="Prism 8" r:id="rId12" imgW="2986605" imgH="141648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75504" y="521387"/>
                        <a:ext cx="1403704" cy="6657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123E69D1-29FE-45BC-818C-4CE410BCB0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4013916"/>
              </p:ext>
            </p:extLst>
          </p:nvPr>
        </p:nvGraphicFramePr>
        <p:xfrm>
          <a:off x="3381713" y="546335"/>
          <a:ext cx="1321650" cy="64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922501" imgH="1415045" progId="Prism8.Document">
                  <p:embed/>
                </p:oleObj>
              </mc:Choice>
              <mc:Fallback>
                <p:oleObj name="Prism 8" r:id="rId14" imgW="2922501" imgH="1415045" progId="Prism8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81713" y="546335"/>
                        <a:ext cx="1321650" cy="64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053573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5</TotalTime>
  <Words>20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8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159</cp:revision>
  <dcterms:created xsi:type="dcterms:W3CDTF">2019-12-12T14:09:36Z</dcterms:created>
  <dcterms:modified xsi:type="dcterms:W3CDTF">2021-02-04T10:21:12Z</dcterms:modified>
</cp:coreProperties>
</file>